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</p:sldIdLst>
  <p:sldSz cx="9144000" cy="1206976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D" lastIdx="14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6" d="100"/>
          <a:sy n="56" d="100"/>
        </p:scale>
        <p:origin x="2128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75307"/>
            <a:ext cx="7772400" cy="4202066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339420"/>
            <a:ext cx="6858000" cy="291406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4177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880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42603"/>
            <a:ext cx="1971675" cy="1022856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42603"/>
            <a:ext cx="5800725" cy="1022856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718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2649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009063"/>
            <a:ext cx="7886700" cy="5020685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077245"/>
            <a:ext cx="7886700" cy="2640260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9311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213015"/>
            <a:ext cx="3886200" cy="765815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213015"/>
            <a:ext cx="3886200" cy="765815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4276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42606"/>
            <a:ext cx="7886700" cy="233293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58769"/>
            <a:ext cx="3868340" cy="145004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408816"/>
            <a:ext cx="3868340" cy="64847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58769"/>
            <a:ext cx="3887391" cy="145004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408816"/>
            <a:ext cx="3887391" cy="648470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385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5130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38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04651"/>
            <a:ext cx="2949178" cy="2816278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37825"/>
            <a:ext cx="4629150" cy="857735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20929"/>
            <a:ext cx="2949178" cy="670821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0375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04651"/>
            <a:ext cx="2949178" cy="2816278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37825"/>
            <a:ext cx="4629150" cy="857735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20929"/>
            <a:ext cx="2949178" cy="670821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571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42606"/>
            <a:ext cx="7886700" cy="23329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213015"/>
            <a:ext cx="7886700" cy="76581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186885"/>
            <a:ext cx="2057400" cy="6426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E8300-6728-4B2F-AEDD-9476D745A03B}" type="datetimeFigureOut">
              <a:rPr kumimoji="1" lang="ja-JP" altLang="en-US" smtClean="0"/>
              <a:t>2022/3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186885"/>
            <a:ext cx="3086100" cy="6426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186885"/>
            <a:ext cx="2057400" cy="6426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C0212-9FC2-4C00-BD1A-11A16EE9A6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0801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5449137-093A-4877-A353-26463491E116}"/>
              </a:ext>
            </a:extLst>
          </p:cNvPr>
          <p:cNvSpPr/>
          <p:nvPr/>
        </p:nvSpPr>
        <p:spPr>
          <a:xfrm>
            <a:off x="815500" y="395249"/>
            <a:ext cx="7288418" cy="14348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ruitment via a website in Japan</a:t>
            </a:r>
          </a:p>
          <a:p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 Parents</a:t>
            </a:r>
            <a:r>
              <a:rPr kumimoji="1" lang="ja-JP" alt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ed from 30 to 59 years who have daughter from 6</a:t>
            </a:r>
            <a:r>
              <a:rPr kumimoji="1" lang="en-US" altLang="ja-JP" sz="12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rade elementary- to 3</a:t>
            </a:r>
            <a:r>
              <a:rPr kumimoji="1" lang="en-US" altLang="ja-JP" sz="12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rade high school student</a:t>
            </a:r>
          </a:p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-  Obtaining informed consent</a:t>
            </a:r>
          </a:p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-  Excluded those who already have their daughters gotten HPVV </a:t>
            </a:r>
          </a:p>
          <a:p>
            <a:r>
              <a:rPr kumimoji="1" lang="en-US" altLang="ja-JP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             n=2,175</a:t>
            </a:r>
            <a:r>
              <a:rPr kumimoji="1" lang="en-US" altLang="ja-JP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BA83E4CB-8EBA-4668-A1B4-AE1E72E2CCDA}"/>
              </a:ext>
            </a:extLst>
          </p:cNvPr>
          <p:cNvSpPr/>
          <p:nvPr/>
        </p:nvSpPr>
        <p:spPr>
          <a:xfrm>
            <a:off x="5194440" y="4455645"/>
            <a:ext cx="3568855" cy="7818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[Stratified factors]</a:t>
            </a:r>
          </a:p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- </a:t>
            </a:r>
            <a:r>
              <a:rPr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ex (female, male)</a:t>
            </a:r>
            <a:endParaRPr kumimoji="1" lang="en-US" altLang="ja-JP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- Willingness to HPVV prior to randomization </a:t>
            </a:r>
            <a:endParaRPr lang="en-US" altLang="ja-JP" sz="1200" dirty="0">
              <a:solidFill>
                <a:schemeClr val="tx1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EB428A5C-A5E0-4CA6-96F3-90A025A36CBD}"/>
              </a:ext>
            </a:extLst>
          </p:cNvPr>
          <p:cNvCxnSpPr>
            <a:cxnSpLocks/>
          </p:cNvCxnSpPr>
          <p:nvPr/>
        </p:nvCxnSpPr>
        <p:spPr>
          <a:xfrm>
            <a:off x="4347387" y="1830060"/>
            <a:ext cx="0" cy="50026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3FF03E4B-268F-4679-B966-443B6A3C0036}"/>
              </a:ext>
            </a:extLst>
          </p:cNvPr>
          <p:cNvSpPr/>
          <p:nvPr/>
        </p:nvSpPr>
        <p:spPr>
          <a:xfrm>
            <a:off x="2265876" y="2334153"/>
            <a:ext cx="4171948" cy="7818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75" indent="-285775">
              <a:buFontTx/>
              <a:buChar char="-"/>
            </a:pPr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llection of participants’ background information</a:t>
            </a:r>
          </a:p>
          <a:p>
            <a:pPr marL="285775" indent="-285775">
              <a:buFontTx/>
              <a:buChar char="-"/>
            </a:pPr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llingness to consider HPVV for daughters</a:t>
            </a:r>
          </a:p>
          <a:p>
            <a:pPr marL="285775" indent="-285775">
              <a:buFontTx/>
              <a:buChar char="-"/>
            </a:pPr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1-Q7 (Awareness questions) 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A410CF16-149A-4198-92A2-3BC54731F63D}"/>
              </a:ext>
            </a:extLst>
          </p:cNvPr>
          <p:cNvCxnSpPr>
            <a:cxnSpLocks/>
          </p:cNvCxnSpPr>
          <p:nvPr/>
        </p:nvCxnSpPr>
        <p:spPr>
          <a:xfrm>
            <a:off x="4347389" y="3125460"/>
            <a:ext cx="6627" cy="5433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83BC7346-BCF9-427A-92A3-A8F6D0E4DC15}"/>
              </a:ext>
            </a:extLst>
          </p:cNvPr>
          <p:cNvSpPr/>
          <p:nvPr/>
        </p:nvSpPr>
        <p:spPr>
          <a:xfrm>
            <a:off x="1917274" y="6120034"/>
            <a:ext cx="2157100" cy="632792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ort movie</a:t>
            </a:r>
          </a:p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y a cancer survivor)</a:t>
            </a:r>
            <a:endParaRPr kumimoji="1" lang="ja-JP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C7523560-62F9-4AD4-B6B9-FF87648B2C6D}"/>
              </a:ext>
            </a:extLst>
          </p:cNvPr>
          <p:cNvSpPr/>
          <p:nvPr/>
        </p:nvSpPr>
        <p:spPr>
          <a:xfrm>
            <a:off x="3513589" y="4647390"/>
            <a:ext cx="1680851" cy="470450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ndomization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B632906A-02D1-460A-83C7-DED43AA3B1A3}"/>
              </a:ext>
            </a:extLst>
          </p:cNvPr>
          <p:cNvSpPr/>
          <p:nvPr/>
        </p:nvSpPr>
        <p:spPr>
          <a:xfrm>
            <a:off x="4080696" y="5408560"/>
            <a:ext cx="619330" cy="3031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: 1</a:t>
            </a:r>
            <a:endParaRPr kumimoji="1" lang="en-US" altLang="ja-JP" sz="1600" dirty="0">
              <a:solidFill>
                <a:schemeClr val="tx1"/>
              </a:solidFill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EA64BF6A-C96C-4BA0-8193-E57C7B02B838}"/>
              </a:ext>
            </a:extLst>
          </p:cNvPr>
          <p:cNvCxnSpPr>
            <a:cxnSpLocks/>
          </p:cNvCxnSpPr>
          <p:nvPr/>
        </p:nvCxnSpPr>
        <p:spPr>
          <a:xfrm>
            <a:off x="2992355" y="6769390"/>
            <a:ext cx="6627" cy="5433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EB21A8E1-F6D4-45E4-BE2C-F22554EF5DBE}"/>
              </a:ext>
            </a:extLst>
          </p:cNvPr>
          <p:cNvSpPr/>
          <p:nvPr/>
        </p:nvSpPr>
        <p:spPr>
          <a:xfrm>
            <a:off x="2698131" y="7312728"/>
            <a:ext cx="3294820" cy="54333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ve questions</a:t>
            </a:r>
          </a:p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Willingness questions)</a:t>
            </a:r>
            <a:endParaRPr kumimoji="1" lang="ja-JP" alt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F823D144-358F-44A3-B76A-5F8DD7EC1061}"/>
              </a:ext>
            </a:extLst>
          </p:cNvPr>
          <p:cNvCxnSpPr>
            <a:cxnSpLocks/>
          </p:cNvCxnSpPr>
          <p:nvPr/>
        </p:nvCxnSpPr>
        <p:spPr>
          <a:xfrm>
            <a:off x="5688190" y="6043989"/>
            <a:ext cx="0" cy="12521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C767C18A-F884-4C69-BBAF-D71FEE9BE0FB}"/>
              </a:ext>
            </a:extLst>
          </p:cNvPr>
          <p:cNvSpPr/>
          <p:nvPr/>
        </p:nvSpPr>
        <p:spPr>
          <a:xfrm>
            <a:off x="1587479" y="5702590"/>
            <a:ext cx="2680954" cy="417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group (n=1,089)</a:t>
            </a:r>
            <a:endParaRPr kumimoji="1" lang="en-US" altLang="ja-JP" sz="1600" dirty="0">
              <a:solidFill>
                <a:schemeClr val="tx1"/>
              </a:solidFill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456DA855-9190-4309-94FF-ECEAA106EE09}"/>
              </a:ext>
            </a:extLst>
          </p:cNvPr>
          <p:cNvSpPr/>
          <p:nvPr/>
        </p:nvSpPr>
        <p:spPr>
          <a:xfrm>
            <a:off x="4674101" y="5724597"/>
            <a:ext cx="2538906" cy="417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group (n=1,086)</a:t>
            </a:r>
            <a:endParaRPr kumimoji="1" lang="en-US" altLang="ja-JP" sz="1600" dirty="0">
              <a:solidFill>
                <a:schemeClr val="tx1"/>
              </a:solidFill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423697" y="11284814"/>
            <a:ext cx="26611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VV: Human papillomavirus vaccines</a:t>
            </a:r>
          </a:p>
        </p:txBody>
      </p:sp>
      <p:cxnSp>
        <p:nvCxnSpPr>
          <p:cNvPr id="20" name="直線矢印コネクタ 14">
            <a:extLst>
              <a:ext uri="{FF2B5EF4-FFF2-40B4-BE49-F238E27FC236}">
                <a16:creationId xmlns:a16="http://schemas.microsoft.com/office/drawing/2014/main" id="{B28542E3-6E72-4D74-83CF-608EAF849A65}"/>
              </a:ext>
            </a:extLst>
          </p:cNvPr>
          <p:cNvCxnSpPr>
            <a:cxnSpLocks/>
          </p:cNvCxnSpPr>
          <p:nvPr/>
        </p:nvCxnSpPr>
        <p:spPr>
          <a:xfrm>
            <a:off x="4347389" y="4093699"/>
            <a:ext cx="6627" cy="5433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正方形/長方形 12">
            <a:extLst>
              <a:ext uri="{FF2B5EF4-FFF2-40B4-BE49-F238E27FC236}">
                <a16:creationId xmlns:a16="http://schemas.microsoft.com/office/drawing/2014/main" id="{B72AE671-B742-428F-A1A3-481FA3B459B4}"/>
              </a:ext>
            </a:extLst>
          </p:cNvPr>
          <p:cNvSpPr/>
          <p:nvPr/>
        </p:nvSpPr>
        <p:spPr>
          <a:xfrm>
            <a:off x="1835084" y="3684123"/>
            <a:ext cx="5050316" cy="4021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asic information regarding benefit and side reactions by HPVV</a:t>
            </a:r>
          </a:p>
        </p:txBody>
      </p:sp>
      <p:cxnSp>
        <p:nvCxnSpPr>
          <p:cNvPr id="28" name="直線矢印コネクタ 14">
            <a:extLst>
              <a:ext uri="{FF2B5EF4-FFF2-40B4-BE49-F238E27FC236}">
                <a16:creationId xmlns:a16="http://schemas.microsoft.com/office/drawing/2014/main" id="{8BAC68B5-C3C9-40F7-BF9B-319FF4D87F8D}"/>
              </a:ext>
            </a:extLst>
          </p:cNvPr>
          <p:cNvCxnSpPr>
            <a:cxnSpLocks/>
          </p:cNvCxnSpPr>
          <p:nvPr/>
        </p:nvCxnSpPr>
        <p:spPr>
          <a:xfrm flipH="1">
            <a:off x="3000412" y="5414773"/>
            <a:ext cx="1466" cy="4044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14">
            <a:extLst>
              <a:ext uri="{FF2B5EF4-FFF2-40B4-BE49-F238E27FC236}">
                <a16:creationId xmlns:a16="http://schemas.microsoft.com/office/drawing/2014/main" id="{2B63C9C6-F263-42ED-96D2-0446CB6E9A55}"/>
              </a:ext>
            </a:extLst>
          </p:cNvPr>
          <p:cNvCxnSpPr>
            <a:cxnSpLocks/>
          </p:cNvCxnSpPr>
          <p:nvPr/>
        </p:nvCxnSpPr>
        <p:spPr>
          <a:xfrm>
            <a:off x="5679016" y="5414773"/>
            <a:ext cx="9174" cy="4061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D5BBB8E2-C60A-4732-888E-55002ACAE2C3}"/>
              </a:ext>
            </a:extLst>
          </p:cNvPr>
          <p:cNvCxnSpPr/>
          <p:nvPr/>
        </p:nvCxnSpPr>
        <p:spPr>
          <a:xfrm>
            <a:off x="2998981" y="5414771"/>
            <a:ext cx="268095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C31E3FED-E674-443D-B239-352031A526FA}"/>
              </a:ext>
            </a:extLst>
          </p:cNvPr>
          <p:cNvCxnSpPr>
            <a:endCxn id="23" idx="2"/>
          </p:cNvCxnSpPr>
          <p:nvPr/>
        </p:nvCxnSpPr>
        <p:spPr>
          <a:xfrm flipV="1">
            <a:off x="4354013" y="5117842"/>
            <a:ext cx="1" cy="29693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正方形/長方形 25">
            <a:extLst>
              <a:ext uri="{FF2B5EF4-FFF2-40B4-BE49-F238E27FC236}">
                <a16:creationId xmlns:a16="http://schemas.microsoft.com/office/drawing/2014/main" id="{82DD0D4B-3A43-47F6-9215-83486709C78F}"/>
              </a:ext>
            </a:extLst>
          </p:cNvPr>
          <p:cNvSpPr/>
          <p:nvPr/>
        </p:nvSpPr>
        <p:spPr>
          <a:xfrm>
            <a:off x="2458538" y="8414994"/>
            <a:ext cx="3790949" cy="81671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llow-up questionnaire</a:t>
            </a:r>
          </a:p>
          <a:p>
            <a:pPr algn="ctr"/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Willingness and behavior questions)</a:t>
            </a:r>
          </a:p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1,807 </a:t>
            </a:r>
            <a:r>
              <a: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83.1%)</a:t>
            </a:r>
          </a:p>
        </p:txBody>
      </p:sp>
      <p:cxnSp>
        <p:nvCxnSpPr>
          <p:cNvPr id="35" name="直線矢印コネクタ 14">
            <a:extLst>
              <a:ext uri="{FF2B5EF4-FFF2-40B4-BE49-F238E27FC236}">
                <a16:creationId xmlns:a16="http://schemas.microsoft.com/office/drawing/2014/main" id="{7E88B18A-2AB8-4190-9993-0CF344A6CDC9}"/>
              </a:ext>
            </a:extLst>
          </p:cNvPr>
          <p:cNvCxnSpPr>
            <a:cxnSpLocks/>
          </p:cNvCxnSpPr>
          <p:nvPr/>
        </p:nvCxnSpPr>
        <p:spPr>
          <a:xfrm>
            <a:off x="2998983" y="7856066"/>
            <a:ext cx="6627" cy="5433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正方形/長方形 21">
            <a:extLst>
              <a:ext uri="{FF2B5EF4-FFF2-40B4-BE49-F238E27FC236}">
                <a16:creationId xmlns:a16="http://schemas.microsoft.com/office/drawing/2014/main" id="{A5B2EAE1-BD9C-449A-8F3B-6E45758A69A2}"/>
              </a:ext>
            </a:extLst>
          </p:cNvPr>
          <p:cNvSpPr/>
          <p:nvPr/>
        </p:nvSpPr>
        <p:spPr>
          <a:xfrm>
            <a:off x="4603780" y="10380298"/>
            <a:ext cx="2157100" cy="632792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ort movie</a:t>
            </a:r>
          </a:p>
          <a:p>
            <a:pPr algn="ctr"/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y a cancer survivor)</a:t>
            </a:r>
            <a:endParaRPr kumimoji="1" lang="ja-JP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線矢印コネクタ 24">
            <a:extLst>
              <a:ext uri="{FF2B5EF4-FFF2-40B4-BE49-F238E27FC236}">
                <a16:creationId xmlns:a16="http://schemas.microsoft.com/office/drawing/2014/main" id="{EFBC9AEC-A746-450A-8795-620EE3D2C7F3}"/>
              </a:ext>
            </a:extLst>
          </p:cNvPr>
          <p:cNvCxnSpPr>
            <a:cxnSpLocks/>
          </p:cNvCxnSpPr>
          <p:nvPr/>
        </p:nvCxnSpPr>
        <p:spPr>
          <a:xfrm>
            <a:off x="5682330" y="9818781"/>
            <a:ext cx="0" cy="535428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14">
            <a:extLst>
              <a:ext uri="{FF2B5EF4-FFF2-40B4-BE49-F238E27FC236}">
                <a16:creationId xmlns:a16="http://schemas.microsoft.com/office/drawing/2014/main" id="{73320E87-7610-4524-A9AB-0D5E5E8CDCB3}"/>
              </a:ext>
            </a:extLst>
          </p:cNvPr>
          <p:cNvCxnSpPr>
            <a:cxnSpLocks/>
          </p:cNvCxnSpPr>
          <p:nvPr/>
        </p:nvCxnSpPr>
        <p:spPr>
          <a:xfrm>
            <a:off x="5675703" y="7864720"/>
            <a:ext cx="6627" cy="5433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正方形/長方形 6">
            <a:extLst>
              <a:ext uri="{FF2B5EF4-FFF2-40B4-BE49-F238E27FC236}">
                <a16:creationId xmlns:a16="http://schemas.microsoft.com/office/drawing/2014/main" id="{E0E5CEA2-34C6-44F6-A673-D5D3399C1A79}"/>
              </a:ext>
            </a:extLst>
          </p:cNvPr>
          <p:cNvSpPr/>
          <p:nvPr/>
        </p:nvSpPr>
        <p:spPr>
          <a:xfrm>
            <a:off x="5742464" y="9890818"/>
            <a:ext cx="2286703" cy="41744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ptional by participant’s will </a:t>
            </a:r>
            <a:endParaRPr lang="en-US" altLang="ja-JP" sz="1200" dirty="0">
              <a:solidFill>
                <a:schemeClr val="tx1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0" name="正方形/長方形 6">
            <a:extLst>
              <a:ext uri="{FF2B5EF4-FFF2-40B4-BE49-F238E27FC236}">
                <a16:creationId xmlns:a16="http://schemas.microsoft.com/office/drawing/2014/main" id="{5CF3D45E-9F3E-4CF3-B195-249A12CAC77B}"/>
              </a:ext>
            </a:extLst>
          </p:cNvPr>
          <p:cNvSpPr/>
          <p:nvPr/>
        </p:nvSpPr>
        <p:spPr>
          <a:xfrm>
            <a:off x="3630065" y="8042251"/>
            <a:ext cx="1520592" cy="41744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600" b="1" dirty="0">
                <a:solidFill>
                  <a:schemeClr val="tx1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fter 3 months </a:t>
            </a:r>
            <a:endParaRPr lang="en-US" altLang="ja-JP" sz="1600" b="1" dirty="0">
              <a:solidFill>
                <a:schemeClr val="tx1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84D67009-156E-4013-A074-BF22E08F0874}"/>
              </a:ext>
            </a:extLst>
          </p:cNvPr>
          <p:cNvSpPr/>
          <p:nvPr/>
        </p:nvSpPr>
        <p:spPr>
          <a:xfrm>
            <a:off x="2214153" y="9318166"/>
            <a:ext cx="1760713" cy="417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group </a:t>
            </a:r>
          </a:p>
          <a:p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976, 89.6%)</a:t>
            </a:r>
            <a:endParaRPr kumimoji="1" lang="en-US" altLang="ja-JP" sz="1600" dirty="0">
              <a:solidFill>
                <a:schemeClr val="tx1"/>
              </a:solidFill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77753243-1DA1-43F7-9D0B-4A4390FD597E}"/>
              </a:ext>
            </a:extLst>
          </p:cNvPr>
          <p:cNvSpPr/>
          <p:nvPr/>
        </p:nvSpPr>
        <p:spPr>
          <a:xfrm>
            <a:off x="5008917" y="9339407"/>
            <a:ext cx="1651290" cy="417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group </a:t>
            </a:r>
          </a:p>
          <a:p>
            <a:r>
              <a:rPr kumimoji="1" lang="en-US" altLang="ja-JP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831, 76.5%)</a:t>
            </a:r>
            <a:endParaRPr kumimoji="1" lang="en-US" altLang="ja-JP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58393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5</TotalTime>
  <Words>180</Words>
  <Application>Microsoft Office PowerPoint</Application>
  <PresentationFormat>ユーザー設定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io Suzuki</dc:creator>
  <cp:lastModifiedBy>Suzuki Yukio</cp:lastModifiedBy>
  <cp:revision>66</cp:revision>
  <cp:lastPrinted>2018-02-09T06:49:48Z</cp:lastPrinted>
  <dcterms:created xsi:type="dcterms:W3CDTF">2018-02-08T10:36:10Z</dcterms:created>
  <dcterms:modified xsi:type="dcterms:W3CDTF">2022-03-01T22:41:56Z</dcterms:modified>
</cp:coreProperties>
</file>